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8/0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06306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49170" y="5347451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eni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0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302896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effectLst/>
                <a:latin typeface="+mj-lt"/>
                <a:ea typeface="Calibri" panose="020F0502020204030204" pitchFamily="34" charset="0"/>
              </a:rPr>
              <a:t>Putative model of brain insulin’s role in peripheral metabolism and the impact of brain insulin resistance</a:t>
            </a:r>
            <a:endParaRPr lang="en-GB" sz="2400" b="1" dirty="0">
              <a:latin typeface="+mj-lt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AE32D49-406B-963F-8428-E505FFF92B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85071" y="128002"/>
            <a:ext cx="4639085" cy="5805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55576" y="5659111"/>
            <a:ext cx="71287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eni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2024) Diabetologia DOI 10.1007/s00125-024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0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Author(s),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r>
              <a:rPr lang="en-GB" sz="1200" dirty="0"/>
              <a:t>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dirty="0">
                <a:effectLst/>
                <a:latin typeface="+mj-lt"/>
                <a:ea typeface="Calibri" panose="020F0502020204030204" pitchFamily="34" charset="0"/>
              </a:rPr>
              <a:t>Overview of brain insulin action derived effects on peripheral metabolism</a:t>
            </a:r>
            <a:endParaRPr lang="en-GB" sz="2400" b="1" dirty="0">
              <a:latin typeface="+mj-lt"/>
            </a:endParaRP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3C49399-88D6-EA80-12D9-E9DC3800C6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9069" y="1196752"/>
            <a:ext cx="8525861" cy="457596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On-screen Show (4:3)</PresentationFormat>
  <Paragraphs>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7</cp:revision>
  <dcterms:created xsi:type="dcterms:W3CDTF">2016-06-15T12:53:43Z</dcterms:created>
  <dcterms:modified xsi:type="dcterms:W3CDTF">2024-02-08T16:14:53Z</dcterms:modified>
</cp:coreProperties>
</file>